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69" d="100"/>
          <a:sy n="69" d="100"/>
        </p:scale>
        <p:origin x="151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26FA3-A91D-4F5F-A67F-9FBE39435FCF}" type="datetimeFigureOut">
              <a:rPr lang="en-US" smtClean="0"/>
              <a:t>19-Nov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DEFEA-E4B9-468F-B514-67FAF423D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9533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26FA3-A91D-4F5F-A67F-9FBE39435FCF}" type="datetimeFigureOut">
              <a:rPr lang="en-US" smtClean="0"/>
              <a:t>19-Nov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DEFEA-E4B9-468F-B514-67FAF423D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291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26FA3-A91D-4F5F-A67F-9FBE39435FCF}" type="datetimeFigureOut">
              <a:rPr lang="en-US" smtClean="0"/>
              <a:t>19-Nov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DEFEA-E4B9-468F-B514-67FAF423D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0279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26FA3-A91D-4F5F-A67F-9FBE39435FCF}" type="datetimeFigureOut">
              <a:rPr lang="en-US" smtClean="0"/>
              <a:t>19-Nov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DEFEA-E4B9-468F-B514-67FAF423D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315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26FA3-A91D-4F5F-A67F-9FBE39435FCF}" type="datetimeFigureOut">
              <a:rPr lang="en-US" smtClean="0"/>
              <a:t>19-Nov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DEFEA-E4B9-468F-B514-67FAF423D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3287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26FA3-A91D-4F5F-A67F-9FBE39435FCF}" type="datetimeFigureOut">
              <a:rPr lang="en-US" smtClean="0"/>
              <a:t>19-Nov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DEFEA-E4B9-468F-B514-67FAF423D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34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26FA3-A91D-4F5F-A67F-9FBE39435FCF}" type="datetimeFigureOut">
              <a:rPr lang="en-US" smtClean="0"/>
              <a:t>19-Nov-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DEFEA-E4B9-468F-B514-67FAF423D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13423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26FA3-A91D-4F5F-A67F-9FBE39435FCF}" type="datetimeFigureOut">
              <a:rPr lang="en-US" smtClean="0"/>
              <a:t>19-Nov-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DEFEA-E4B9-468F-B514-67FAF423D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754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26FA3-A91D-4F5F-A67F-9FBE39435FCF}" type="datetimeFigureOut">
              <a:rPr lang="en-US" smtClean="0"/>
              <a:t>19-Nov-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DEFEA-E4B9-468F-B514-67FAF423D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306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26FA3-A91D-4F5F-A67F-9FBE39435FCF}" type="datetimeFigureOut">
              <a:rPr lang="en-US" smtClean="0"/>
              <a:t>19-Nov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DEFEA-E4B9-468F-B514-67FAF423D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6746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26FA3-A91D-4F5F-A67F-9FBE39435FCF}" type="datetimeFigureOut">
              <a:rPr lang="en-US" smtClean="0"/>
              <a:t>19-Nov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DEFEA-E4B9-468F-B514-67FAF423D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935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F26FA3-A91D-4F5F-A67F-9FBE39435FCF}" type="datetimeFigureOut">
              <a:rPr lang="en-US" smtClean="0"/>
              <a:t>19-Nov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3DEFEA-E4B9-468F-B514-67FAF423D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759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7237" y="5603202"/>
            <a:ext cx="4862155" cy="2030425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27225" y="1067539"/>
            <a:ext cx="4902899" cy="1914983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27225" y="7609885"/>
            <a:ext cx="5011550" cy="1833494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75289" y="3098498"/>
            <a:ext cx="4773875" cy="1874238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18988" y="243840"/>
            <a:ext cx="62200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108T OE western blot analysis of PSMB8 and PSMB9 </a:t>
            </a:r>
            <a:r>
              <a:rPr lang="en-US" dirty="0" smtClean="0"/>
              <a:t>expression</a:t>
            </a:r>
          </a:p>
          <a:p>
            <a:pPr algn="ctr"/>
            <a:r>
              <a:rPr lang="en-US" dirty="0" smtClean="0"/>
              <a:t>(Supplementary Figure 6)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377697" y="2499360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35kDa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1439418" y="7109644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35kDa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1395985" y="3297936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0kDa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1393871" y="3116187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5kDa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1526875" y="7994979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0kDa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1524761" y="7813230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5kDa</a:t>
            </a:r>
            <a:endParaRPr lang="en-US" sz="1200" dirty="0"/>
          </a:p>
        </p:txBody>
      </p:sp>
      <p:cxnSp>
        <p:nvCxnSpPr>
          <p:cNvPr id="16" name="Straight Arrow Connector 15"/>
          <p:cNvCxnSpPr/>
          <p:nvPr/>
        </p:nvCxnSpPr>
        <p:spPr>
          <a:xfrm flipH="1">
            <a:off x="5474208" y="2718816"/>
            <a:ext cx="560832" cy="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5449824" y="2494972"/>
            <a:ext cx="780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APDH</a:t>
            </a:r>
            <a:endParaRPr lang="en-US" sz="1200" dirty="0"/>
          </a:p>
        </p:txBody>
      </p:sp>
      <p:cxnSp>
        <p:nvCxnSpPr>
          <p:cNvPr id="18" name="Straight Arrow Connector 17"/>
          <p:cNvCxnSpPr/>
          <p:nvPr/>
        </p:nvCxnSpPr>
        <p:spPr>
          <a:xfrm flipH="1">
            <a:off x="5443728" y="3541776"/>
            <a:ext cx="560832" cy="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5419344" y="3317932"/>
            <a:ext cx="780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SMB8</a:t>
            </a:r>
            <a:endParaRPr lang="en-US" sz="1200" dirty="0"/>
          </a:p>
        </p:txBody>
      </p:sp>
      <p:cxnSp>
        <p:nvCxnSpPr>
          <p:cNvPr id="20" name="Straight Arrow Connector 19"/>
          <p:cNvCxnSpPr/>
          <p:nvPr/>
        </p:nvCxnSpPr>
        <p:spPr>
          <a:xfrm flipH="1">
            <a:off x="5309616" y="7248144"/>
            <a:ext cx="560832" cy="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5285232" y="7024300"/>
            <a:ext cx="780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APDH</a:t>
            </a:r>
            <a:endParaRPr lang="en-US" sz="1200" dirty="0"/>
          </a:p>
        </p:txBody>
      </p:sp>
      <p:cxnSp>
        <p:nvCxnSpPr>
          <p:cNvPr id="22" name="Straight Arrow Connector 21"/>
          <p:cNvCxnSpPr/>
          <p:nvPr/>
        </p:nvCxnSpPr>
        <p:spPr>
          <a:xfrm flipH="1">
            <a:off x="5327904" y="8229600"/>
            <a:ext cx="560832" cy="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5303520" y="8005756"/>
            <a:ext cx="780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SMB9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381660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52367" y="3446145"/>
            <a:ext cx="5182776" cy="168459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59215" y="7360920"/>
            <a:ext cx="5298786" cy="184564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94103" y="1040669"/>
            <a:ext cx="5099305" cy="240547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94103" y="5554258"/>
            <a:ext cx="5186754" cy="179447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18988" y="243840"/>
            <a:ext cx="62200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12T OE western blot analysis of PSMB8 and PSMB9 </a:t>
            </a:r>
            <a:r>
              <a:rPr lang="en-US" dirty="0" smtClean="0"/>
              <a:t>expression</a:t>
            </a:r>
          </a:p>
          <a:p>
            <a:pPr algn="ctr"/>
            <a:r>
              <a:rPr lang="en-US" dirty="0"/>
              <a:t>(Supplementary Figure 6</a:t>
            </a:r>
            <a:r>
              <a:rPr lang="en-US" dirty="0" smtClean="0"/>
              <a:t>)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584961" y="2913888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35kDa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1676401" y="6894576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35kDa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1554481" y="3883152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0kDa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1552367" y="3701403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5kDa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1552367" y="7551718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0kDa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1550253" y="7369969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5kDa</a:t>
            </a:r>
            <a:endParaRPr lang="en-US" sz="1200" dirty="0"/>
          </a:p>
        </p:txBody>
      </p:sp>
      <p:cxnSp>
        <p:nvCxnSpPr>
          <p:cNvPr id="16" name="Straight Arrow Connector 15"/>
          <p:cNvCxnSpPr/>
          <p:nvPr/>
        </p:nvCxnSpPr>
        <p:spPr>
          <a:xfrm flipH="1">
            <a:off x="5474208" y="3084576"/>
            <a:ext cx="560832" cy="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5449824" y="2860732"/>
            <a:ext cx="780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APDH</a:t>
            </a:r>
            <a:endParaRPr lang="en-US" sz="1200" dirty="0"/>
          </a:p>
        </p:txBody>
      </p:sp>
      <p:cxnSp>
        <p:nvCxnSpPr>
          <p:cNvPr id="18" name="Straight Arrow Connector 17"/>
          <p:cNvCxnSpPr/>
          <p:nvPr/>
        </p:nvCxnSpPr>
        <p:spPr>
          <a:xfrm flipH="1">
            <a:off x="5443728" y="3907536"/>
            <a:ext cx="560832" cy="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5419344" y="3683692"/>
            <a:ext cx="780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SMB8</a:t>
            </a:r>
            <a:endParaRPr lang="en-US" sz="1200" dirty="0"/>
          </a:p>
        </p:txBody>
      </p:sp>
      <p:cxnSp>
        <p:nvCxnSpPr>
          <p:cNvPr id="20" name="Straight Arrow Connector 19"/>
          <p:cNvCxnSpPr/>
          <p:nvPr/>
        </p:nvCxnSpPr>
        <p:spPr>
          <a:xfrm flipH="1">
            <a:off x="5090160" y="7162800"/>
            <a:ext cx="560832" cy="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5065776" y="6938956"/>
            <a:ext cx="780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APDH</a:t>
            </a:r>
            <a:endParaRPr lang="en-US" sz="1200" dirty="0"/>
          </a:p>
        </p:txBody>
      </p:sp>
      <p:cxnSp>
        <p:nvCxnSpPr>
          <p:cNvPr id="22" name="Straight Arrow Connector 21"/>
          <p:cNvCxnSpPr/>
          <p:nvPr/>
        </p:nvCxnSpPr>
        <p:spPr>
          <a:xfrm flipH="1">
            <a:off x="5059680" y="8010144"/>
            <a:ext cx="560832" cy="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5035296" y="7786300"/>
            <a:ext cx="780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SMB9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2406269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4167" y="5448607"/>
            <a:ext cx="5174393" cy="1822165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03717" y="1167032"/>
            <a:ext cx="5035296" cy="202385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74083" y="7330072"/>
            <a:ext cx="4539038" cy="181013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17626" y="3256558"/>
            <a:ext cx="5007477" cy="147442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18988" y="243840"/>
            <a:ext cx="62200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A375 OE western blot analysis of PSMB8 and PSMB9 </a:t>
            </a:r>
            <a:r>
              <a:rPr lang="en-US" dirty="0" smtClean="0"/>
              <a:t>expression</a:t>
            </a:r>
          </a:p>
          <a:p>
            <a:pPr algn="ctr"/>
            <a:r>
              <a:rPr lang="en-US" dirty="0"/>
              <a:t>(Supplementary Figure 6</a:t>
            </a:r>
            <a:r>
              <a:rPr lang="en-US" dirty="0" smtClean="0"/>
              <a:t>)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755649" y="2804160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35kDa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1676401" y="6894576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35kDa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1761745" y="3553968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0kDa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1759631" y="3372219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5kDa</a:t>
            </a:r>
            <a:endParaRPr lang="en-US" sz="1200" dirty="0"/>
          </a:p>
        </p:txBody>
      </p:sp>
      <p:cxnSp>
        <p:nvCxnSpPr>
          <p:cNvPr id="16" name="Straight Arrow Connector 15"/>
          <p:cNvCxnSpPr/>
          <p:nvPr/>
        </p:nvCxnSpPr>
        <p:spPr>
          <a:xfrm flipH="1">
            <a:off x="5474208" y="3084576"/>
            <a:ext cx="560832" cy="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5449824" y="2860732"/>
            <a:ext cx="780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APDH</a:t>
            </a:r>
            <a:endParaRPr lang="en-US" sz="1200" dirty="0"/>
          </a:p>
        </p:txBody>
      </p:sp>
      <p:cxnSp>
        <p:nvCxnSpPr>
          <p:cNvPr id="18" name="Straight Arrow Connector 17"/>
          <p:cNvCxnSpPr/>
          <p:nvPr/>
        </p:nvCxnSpPr>
        <p:spPr>
          <a:xfrm flipH="1">
            <a:off x="5468112" y="3688080"/>
            <a:ext cx="560832" cy="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5443728" y="3464236"/>
            <a:ext cx="780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SMB8</a:t>
            </a:r>
            <a:endParaRPr lang="en-US" sz="1200" dirty="0"/>
          </a:p>
        </p:txBody>
      </p:sp>
      <p:cxnSp>
        <p:nvCxnSpPr>
          <p:cNvPr id="20" name="Straight Arrow Connector 19"/>
          <p:cNvCxnSpPr/>
          <p:nvPr/>
        </p:nvCxnSpPr>
        <p:spPr>
          <a:xfrm flipH="1">
            <a:off x="5382768" y="7053072"/>
            <a:ext cx="560832" cy="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5358384" y="6829228"/>
            <a:ext cx="780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APDH</a:t>
            </a:r>
            <a:endParaRPr lang="en-US" sz="1200" dirty="0"/>
          </a:p>
        </p:txBody>
      </p:sp>
      <p:cxnSp>
        <p:nvCxnSpPr>
          <p:cNvPr id="22" name="Straight Arrow Connector 21"/>
          <p:cNvCxnSpPr/>
          <p:nvPr/>
        </p:nvCxnSpPr>
        <p:spPr>
          <a:xfrm flipH="1">
            <a:off x="5352288" y="8205216"/>
            <a:ext cx="560832" cy="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5327904" y="7981372"/>
            <a:ext cx="780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SMB9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1272009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299" y="4472815"/>
            <a:ext cx="3022601" cy="127515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4058" y="1797629"/>
            <a:ext cx="3094895" cy="269503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25850" y="4447166"/>
            <a:ext cx="2993727" cy="144778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63950" y="1797629"/>
            <a:ext cx="3075522" cy="2789237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18988" y="243840"/>
            <a:ext cx="622002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PSMB8 and PSMB9 expression in 12T and 108T cells after treatment with </a:t>
            </a:r>
            <a:r>
              <a:rPr lang="en-US" dirty="0" err="1" smtClean="0"/>
              <a:t>IFN</a:t>
            </a:r>
            <a:r>
              <a:rPr lang="en-US" dirty="0" err="1" smtClean="0">
                <a:latin typeface="Symbol" panose="05050102010706020507" pitchFamily="18" charset="2"/>
              </a:rPr>
              <a:t>g</a:t>
            </a:r>
            <a:endParaRPr lang="en-US" dirty="0" smtClean="0">
              <a:latin typeface="Symbol" panose="05050102010706020507" pitchFamily="18" charset="2"/>
            </a:endParaRPr>
          </a:p>
          <a:p>
            <a:pPr algn="ctr"/>
            <a:r>
              <a:rPr lang="en-US" dirty="0"/>
              <a:t>(Supplementary Figure 6)</a:t>
            </a:r>
          </a:p>
          <a:p>
            <a:pPr algn="ctr"/>
            <a:endParaRPr lang="en-US" dirty="0">
              <a:latin typeface="Symbol" panose="05050102010706020507" pitchFamily="18" charset="2"/>
            </a:endParaRPr>
          </a:p>
        </p:txBody>
      </p:sp>
      <p:cxnSp>
        <p:nvCxnSpPr>
          <p:cNvPr id="9" name="Straight Arrow Connector 8"/>
          <p:cNvCxnSpPr/>
          <p:nvPr/>
        </p:nvCxnSpPr>
        <p:spPr>
          <a:xfrm flipH="1">
            <a:off x="6173253" y="4121848"/>
            <a:ext cx="560832" cy="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5958369" y="3847204"/>
            <a:ext cx="780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APDH</a:t>
            </a:r>
            <a:endParaRPr lang="en-US" sz="1200" dirty="0"/>
          </a:p>
        </p:txBody>
      </p:sp>
      <p:cxnSp>
        <p:nvCxnSpPr>
          <p:cNvPr id="11" name="Straight Arrow Connector 10"/>
          <p:cNvCxnSpPr/>
          <p:nvPr/>
        </p:nvCxnSpPr>
        <p:spPr>
          <a:xfrm flipH="1">
            <a:off x="3053193" y="4928665"/>
            <a:ext cx="560832" cy="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2647809" y="4654021"/>
            <a:ext cx="780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SMB8</a:t>
            </a:r>
            <a:endParaRPr lang="en-US" sz="1200" dirty="0"/>
          </a:p>
        </p:txBody>
      </p:sp>
      <p:cxnSp>
        <p:nvCxnSpPr>
          <p:cNvPr id="13" name="Straight Arrow Connector 12"/>
          <p:cNvCxnSpPr/>
          <p:nvPr/>
        </p:nvCxnSpPr>
        <p:spPr>
          <a:xfrm flipH="1">
            <a:off x="3156642" y="4126684"/>
            <a:ext cx="560832" cy="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2700458" y="3826640"/>
            <a:ext cx="780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APDH</a:t>
            </a:r>
            <a:endParaRPr lang="en-US" sz="1200" dirty="0"/>
          </a:p>
        </p:txBody>
      </p:sp>
      <p:cxnSp>
        <p:nvCxnSpPr>
          <p:cNvPr id="15" name="Straight Arrow Connector 14"/>
          <p:cNvCxnSpPr/>
          <p:nvPr/>
        </p:nvCxnSpPr>
        <p:spPr>
          <a:xfrm flipH="1">
            <a:off x="6199124" y="5150417"/>
            <a:ext cx="560832" cy="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5984240" y="4901173"/>
            <a:ext cx="780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SMB9</a:t>
            </a:r>
            <a:endParaRPr lang="en-US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203250" y="3832680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35kDa</a:t>
            </a:r>
            <a:endParaRPr lang="en-US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79216" y="4721470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0kDa</a:t>
            </a:r>
            <a:endParaRPr lang="en-US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77102" y="4539721"/>
            <a:ext cx="60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5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7518892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06</TotalTime>
  <Words>98</Words>
  <Application>Microsoft Office PowerPoint</Application>
  <PresentationFormat>A4 Paper (210x297 mm)</PresentationFormat>
  <Paragraphs>4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Weizmann Institute of Scienc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lly Kalaora</dc:creator>
  <cp:lastModifiedBy>Shelly Kalaora</cp:lastModifiedBy>
  <cp:revision>14</cp:revision>
  <dcterms:created xsi:type="dcterms:W3CDTF">2019-07-28T15:56:31Z</dcterms:created>
  <dcterms:modified xsi:type="dcterms:W3CDTF">2019-11-19T09:36:24Z</dcterms:modified>
</cp:coreProperties>
</file>